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7DD4FA-D2F1-4FB8-AF55-78F524BFBC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D7066A-7FA5-45E2-935D-5C6EFD6691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CB238-3979-4D50-9A43-68CFD74E82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AF05F8-F887-435D-ADB5-01EA420C7A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4FA74D-B382-4355-B504-ABB3440B7B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11E672-0975-4F86-AC0B-AF869650C6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1723F6-C270-4D5F-89CE-FCA6818B09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590E25-A2A2-49C9-B867-B0567AE789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E5DF1B-8C96-4DC0-B8EF-606FDBCE26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ED658B-CAF1-446A-A18C-696445F75A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806818-93E2-450A-8476-CDC1E3F649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E16CF2-9BF0-4252-8294-8BFECE9850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2F7615-0B1E-4312-80C9-BCD930928DC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262160" y="1316160"/>
          <a:ext cx="4292640" cy="2714400"/>
        </p:xfrm>
        <a:graphic>
          <a:graphicData uri="http://schemas.openxmlformats.org/drawingml/2006/table">
            <a:tbl>
              <a:tblPr/>
              <a:tblGrid>
                <a:gridCol w="882720"/>
                <a:gridCol w="596880"/>
                <a:gridCol w="706320"/>
                <a:gridCol w="704880"/>
                <a:gridCol w="695160"/>
                <a:gridCol w="706680"/>
              </a:tblGrid>
              <a:tr h="3744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las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B:SPP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 KB:SP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% of al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 By Clas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% of al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224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a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: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5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6.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4.9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</a:tr>
              <a:tr h="192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: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.5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9800">
                <a:tc rowSpan="3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ets (KB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: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.9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 rowSpan="3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</a:tr>
              <a:tr h="193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: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2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: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9800">
                <a:tc rowSpan="3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 Call (KB=Q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: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 rowSpan="3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</a:tr>
              <a:tr h="192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: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1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: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0016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consistant (SPP=I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: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</a:tr>
              <a:tr h="192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: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a5a5a5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9800"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corre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: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a5a5a5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36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: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42" name="Rectangle 1"/>
          <p:cNvSpPr/>
          <p:nvPr/>
        </p:nvSpPr>
        <p:spPr>
          <a:xfrm>
            <a:off x="1262160" y="1048320"/>
            <a:ext cx="381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Table S2. Accuracy of SPP call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9"/>
          <p:cNvSpPr/>
          <p:nvPr/>
        </p:nvSpPr>
        <p:spPr>
          <a:xfrm>
            <a:off x="1262160" y="4021200"/>
            <a:ext cx="43336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Using allele-specific PCR, comparison of 27 SPPs/SNPs  x 43 genotypes for a total of 1161 allele calls.   SPP dataset:  Min SFPdev Ratio = 1.2, 2 probes, 4 bases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13T04:23:38Z</dcterms:created>
  <dc:creator>Theresa Hill</dc:creator>
  <dc:description/>
  <dc:language>en-US</dc:language>
  <cp:lastModifiedBy>Theresa Hill</cp:lastModifiedBy>
  <dcterms:modified xsi:type="dcterms:W3CDTF">2012-03-13T04:31:04Z</dcterms:modified>
  <cp:revision>2</cp:revision>
  <dc:subject/>
  <dc:title>PowerPoint Presentation</dc:title>
</cp:coreProperties>
</file>